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2" autoAdjust="0"/>
    <p:restoredTop sz="94660"/>
  </p:normalViewPr>
  <p:slideViewPr>
    <p:cSldViewPr snapToGrid="0">
      <p:cViewPr varScale="1">
        <p:scale>
          <a:sx n="83" d="100"/>
          <a:sy n="83" d="100"/>
        </p:scale>
        <p:origin x="23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6223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1216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4816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734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883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8178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8068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0056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0337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017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28273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8F554A-27D1-47AA-A17C-CCDD0B1F6067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847D62-B52B-46D2-B2ED-9EC764F7D8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19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4122" y="1604209"/>
            <a:ext cx="6703878" cy="6862759"/>
            <a:chOff x="-940440" y="295837"/>
            <a:chExt cx="8398297" cy="9588333"/>
          </a:xfrm>
        </p:grpSpPr>
        <p:sp>
          <p:nvSpPr>
            <p:cNvPr id="4" name="Rectangle 3"/>
            <p:cNvSpPr/>
            <p:nvPr/>
          </p:nvSpPr>
          <p:spPr>
            <a:xfrm>
              <a:off x="1389651" y="1358176"/>
              <a:ext cx="5445186" cy="660403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GB" sz="1200" dirty="0"/>
                <a:t>Participant during questionnaire indicates they are experiencing a high level of stress or emotional </a:t>
              </a:r>
              <a:r>
                <a:rPr lang="en-GB" sz="1200" dirty="0" smtClean="0"/>
                <a:t>distress.</a:t>
              </a:r>
              <a:endParaRPr lang="en-GB" sz="1200" dirty="0"/>
            </a:p>
          </p:txBody>
        </p:sp>
        <p:sp>
          <p:nvSpPr>
            <p:cNvPr id="5" name="Down Arrow 4"/>
            <p:cNvSpPr/>
            <p:nvPr/>
          </p:nvSpPr>
          <p:spPr>
            <a:xfrm>
              <a:off x="-778454" y="1358180"/>
              <a:ext cx="1420484" cy="1806754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601"/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-1209500" y="1210851"/>
              <a:ext cx="2292709" cy="4626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Distress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389651" y="3214568"/>
              <a:ext cx="5445186" cy="645017"/>
            </a:xfrm>
            <a:prstGeom prst="rect">
              <a:avLst/>
            </a:prstGeom>
            <a:solidFill>
              <a:srgbClr val="5B9BD5"/>
            </a:solidFill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chemeClr val="bg1"/>
                  </a:solidFill>
                </a:rPr>
                <a:t>Participant given option to ask for additional support via contact from the research </a:t>
              </a:r>
              <a:r>
                <a:rPr lang="en-GB" sz="1200" dirty="0" smtClean="0">
                  <a:solidFill>
                    <a:schemeClr val="bg1"/>
                  </a:solidFill>
                </a:rPr>
                <a:t>team.</a:t>
              </a:r>
              <a:endParaRPr lang="en-GB" sz="1200" dirty="0">
                <a:solidFill>
                  <a:schemeClr val="bg1"/>
                </a:solidFill>
              </a:endParaRPr>
            </a:p>
          </p:txBody>
        </p:sp>
        <p:sp>
          <p:nvSpPr>
            <p:cNvPr id="8" name="Down Arrow 7"/>
            <p:cNvSpPr/>
            <p:nvPr/>
          </p:nvSpPr>
          <p:spPr>
            <a:xfrm>
              <a:off x="-790916" y="3184577"/>
              <a:ext cx="1445399" cy="2048783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601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389651" y="5233361"/>
              <a:ext cx="5445186" cy="645017"/>
            </a:xfrm>
            <a:prstGeom prst="rect">
              <a:avLst/>
            </a:prstGeom>
            <a:solidFill>
              <a:schemeClr val="accent1"/>
            </a:solidFill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chemeClr val="bg1"/>
                  </a:solidFill>
                </a:rPr>
                <a:t>Participant contacted within 7 days of a positive response to distress and the request to be contact by the research </a:t>
              </a:r>
              <a:r>
                <a:rPr lang="en-GB" sz="1200" dirty="0" smtClean="0">
                  <a:solidFill>
                    <a:schemeClr val="bg1"/>
                  </a:solidFill>
                </a:rPr>
                <a:t>team.</a:t>
              </a:r>
              <a:endParaRPr lang="en-GB" sz="1200" dirty="0">
                <a:solidFill>
                  <a:schemeClr val="bg1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-1058814" y="3261485"/>
              <a:ext cx="1981200" cy="8096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Stage 1 response</a:t>
              </a:r>
            </a:p>
          </p:txBody>
        </p:sp>
        <p:sp>
          <p:nvSpPr>
            <p:cNvPr id="13" name="Down Arrow 12"/>
            <p:cNvSpPr/>
            <p:nvPr/>
          </p:nvSpPr>
          <p:spPr>
            <a:xfrm>
              <a:off x="-765997" y="5253001"/>
              <a:ext cx="1420484" cy="1787113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601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389651" y="7040115"/>
              <a:ext cx="5445186" cy="1159035"/>
            </a:xfrm>
            <a:prstGeom prst="rect">
              <a:avLst/>
            </a:prstGeom>
            <a:solidFill>
              <a:schemeClr val="accent1"/>
            </a:solidFill>
          </p:spPr>
          <p:txBody>
            <a:bodyPr wrap="square" rtlCol="0">
              <a:spAutoFit/>
            </a:bodyPr>
            <a:lstStyle/>
            <a:p>
              <a:r>
                <a:rPr lang="en-GB" sz="1200" dirty="0">
                  <a:solidFill>
                    <a:schemeClr val="bg1"/>
                  </a:solidFill>
                </a:rPr>
                <a:t>Follow-up of participant with a telephone call. Encourage participant to contact their GP or postnatal service if they experience distress. Signposting towards charities they can contact for support.</a:t>
              </a:r>
            </a:p>
          </p:txBody>
        </p:sp>
        <p:sp>
          <p:nvSpPr>
            <p:cNvPr id="15" name="Down Arrow 14"/>
            <p:cNvSpPr/>
            <p:nvPr/>
          </p:nvSpPr>
          <p:spPr>
            <a:xfrm>
              <a:off x="-765997" y="7059758"/>
              <a:ext cx="1420484" cy="2111082"/>
            </a:xfrm>
            <a:prstGeom prst="downArrow">
              <a:avLst/>
            </a:prstGeom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-734847" y="5552905"/>
              <a:ext cx="1333260" cy="4626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Review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-1002746" y="7408941"/>
              <a:ext cx="1869058" cy="4626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Follow-up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-940440" y="388665"/>
              <a:ext cx="8398294" cy="5160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Figure S1: </a:t>
              </a:r>
              <a:r>
                <a:rPr lang="en-GB" dirty="0"/>
                <a:t>Distress Pathway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389653" y="9239153"/>
              <a:ext cx="6068204" cy="645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Protocol for managing distress in the context of research on sensitive subjects (adapted from </a:t>
              </a:r>
              <a:r>
                <a:rPr lang="en-GB" sz="1200" dirty="0" err="1"/>
                <a:t>Draucker</a:t>
              </a:r>
              <a:r>
                <a:rPr lang="en-GB" sz="1200" dirty="0"/>
                <a:t> et al.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22467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114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oB IT Servi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 Man (Applied Health Research)</dc:creator>
  <cp:lastModifiedBy>Rebecca Man (Applied Health Sciences)</cp:lastModifiedBy>
  <cp:revision>6</cp:revision>
  <dcterms:created xsi:type="dcterms:W3CDTF">2023-12-18T12:08:01Z</dcterms:created>
  <dcterms:modified xsi:type="dcterms:W3CDTF">2025-06-09T14:50:14Z</dcterms:modified>
</cp:coreProperties>
</file>